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65" r:id="rId3"/>
    <p:sldId id="266" r:id="rId4"/>
    <p:sldId id="268" r:id="rId5"/>
    <p:sldId id="267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8F8DAE0-6876-4495-8770-31F9B13E4655}" v="91" dt="2023-03-21T19:47:01.41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2" autoAdjust="0"/>
    <p:restoredTop sz="98927" autoAdjust="0"/>
  </p:normalViewPr>
  <p:slideViewPr>
    <p:cSldViewPr snapToGrid="0" snapToObjects="1">
      <p:cViewPr>
        <p:scale>
          <a:sx n="73" d="100"/>
          <a:sy n="73" d="100"/>
        </p:scale>
        <p:origin x="2108" y="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lenn Tissier" userId="0e0e18d6-263e-426d-a4a8-a62c3d92e241" providerId="ADAL" clId="{F8F8DAE0-6876-4495-8770-31F9B13E4655}"/>
    <pc:docChg chg="undo custSel addSld modSld">
      <pc:chgData name="Solenn Tissier" userId="0e0e18d6-263e-426d-a4a8-a62c3d92e241" providerId="ADAL" clId="{F8F8DAE0-6876-4495-8770-31F9B13E4655}" dt="2023-03-21T19:48:56.769" v="1895" actId="1037"/>
      <pc:docMkLst>
        <pc:docMk/>
      </pc:docMkLst>
      <pc:sldChg chg="addSp delSp modSp mod">
        <pc:chgData name="Solenn Tissier" userId="0e0e18d6-263e-426d-a4a8-a62c3d92e241" providerId="ADAL" clId="{F8F8DAE0-6876-4495-8770-31F9B13E4655}" dt="2023-03-18T17:08:08.468" v="1152" actId="20577"/>
        <pc:sldMkLst>
          <pc:docMk/>
          <pc:sldMk cId="838728113" sldId="266"/>
        </pc:sldMkLst>
        <pc:spChg chg="del">
          <ac:chgData name="Solenn Tissier" userId="0e0e18d6-263e-426d-a4a8-a62c3d92e241" providerId="ADAL" clId="{F8F8DAE0-6876-4495-8770-31F9B13E4655}" dt="2023-03-11T14:50:20.354" v="119" actId="478"/>
          <ac:spMkLst>
            <pc:docMk/>
            <pc:sldMk cId="838728113" sldId="266"/>
            <ac:spMk id="2" creationId="{A0B92B5B-182F-69BF-103B-453C7B9BF8C1}"/>
          </ac:spMkLst>
        </pc:spChg>
        <pc:spChg chg="add del">
          <ac:chgData name="Solenn Tissier" userId="0e0e18d6-263e-426d-a4a8-a62c3d92e241" providerId="ADAL" clId="{F8F8DAE0-6876-4495-8770-31F9B13E4655}" dt="2023-03-11T14:46:58.703" v="4"/>
          <ac:spMkLst>
            <pc:docMk/>
            <pc:sldMk cId="838728113" sldId="266"/>
            <ac:spMk id="3" creationId="{EA85F470-A1CB-6631-343D-955B0E0B3100}"/>
          </ac:spMkLst>
        </pc:spChg>
        <pc:spChg chg="add mod">
          <ac:chgData name="Solenn Tissier" userId="0e0e18d6-263e-426d-a4a8-a62c3d92e241" providerId="ADAL" clId="{F8F8DAE0-6876-4495-8770-31F9B13E4655}" dt="2023-03-18T17:08:08.468" v="1152" actId="20577"/>
          <ac:spMkLst>
            <pc:docMk/>
            <pc:sldMk cId="838728113" sldId="266"/>
            <ac:spMk id="8" creationId="{86EFC1D3-A5E4-F763-37F2-C971DF0797BE}"/>
          </ac:spMkLst>
        </pc:spChg>
        <pc:graphicFrameChg chg="add del mod">
          <ac:chgData name="Solenn Tissier" userId="0e0e18d6-263e-426d-a4a8-a62c3d92e241" providerId="ADAL" clId="{F8F8DAE0-6876-4495-8770-31F9B13E4655}" dt="2023-03-11T14:46:58.573" v="3"/>
          <ac:graphicFrameMkLst>
            <pc:docMk/>
            <pc:sldMk cId="838728113" sldId="266"/>
            <ac:graphicFrameMk id="4" creationId="{AE2234AB-D982-128F-3185-A60C6CA34626}"/>
          </ac:graphicFrameMkLst>
        </pc:graphicFrameChg>
        <pc:graphicFrameChg chg="add mod modGraphic">
          <ac:chgData name="Solenn Tissier" userId="0e0e18d6-263e-426d-a4a8-a62c3d92e241" providerId="ADAL" clId="{F8F8DAE0-6876-4495-8770-31F9B13E4655}" dt="2023-03-18T16:54:25.883" v="840" actId="20577"/>
          <ac:graphicFrameMkLst>
            <pc:docMk/>
            <pc:sldMk cId="838728113" sldId="266"/>
            <ac:graphicFrameMk id="5" creationId="{603CCFEF-821F-F4DC-8EE3-0D6F709015FD}"/>
          </ac:graphicFrameMkLst>
        </pc:graphicFrameChg>
        <pc:graphicFrameChg chg="add del mod">
          <ac:chgData name="Solenn Tissier" userId="0e0e18d6-263e-426d-a4a8-a62c3d92e241" providerId="ADAL" clId="{F8F8DAE0-6876-4495-8770-31F9B13E4655}" dt="2023-03-11T14:47:19.960" v="7"/>
          <ac:graphicFrameMkLst>
            <pc:docMk/>
            <pc:sldMk cId="838728113" sldId="266"/>
            <ac:graphicFrameMk id="6" creationId="{3AC81D2D-D10E-7D0A-88D2-A7FDA6569343}"/>
          </ac:graphicFrameMkLst>
        </pc:graphicFrameChg>
        <pc:graphicFrameChg chg="add del mod modGraphic">
          <ac:chgData name="Solenn Tissier" userId="0e0e18d6-263e-426d-a4a8-a62c3d92e241" providerId="ADAL" clId="{F8F8DAE0-6876-4495-8770-31F9B13E4655}" dt="2023-03-11T18:03:39.806" v="205" actId="478"/>
          <ac:graphicFrameMkLst>
            <pc:docMk/>
            <pc:sldMk cId="838728113" sldId="266"/>
            <ac:graphicFrameMk id="7" creationId="{5AD96CA1-E852-33CF-BC39-D01EBE94F2BD}"/>
          </ac:graphicFrameMkLst>
        </pc:graphicFrameChg>
      </pc:sldChg>
      <pc:sldChg chg="addSp delSp modSp new mod">
        <pc:chgData name="Solenn Tissier" userId="0e0e18d6-263e-426d-a4a8-a62c3d92e241" providerId="ADAL" clId="{F8F8DAE0-6876-4495-8770-31F9B13E4655}" dt="2023-03-21T14:11:10.902" v="1839" actId="1037"/>
        <pc:sldMkLst>
          <pc:docMk/>
          <pc:sldMk cId="2191617844" sldId="267"/>
        </pc:sldMkLst>
        <pc:spChg chg="del">
          <ac:chgData name="Solenn Tissier" userId="0e0e18d6-263e-426d-a4a8-a62c3d92e241" providerId="ADAL" clId="{F8F8DAE0-6876-4495-8770-31F9B13E4655}" dt="2023-03-18T16:48:58.097" v="694" actId="478"/>
          <ac:spMkLst>
            <pc:docMk/>
            <pc:sldMk cId="2191617844" sldId="267"/>
            <ac:spMk id="2" creationId="{0DC2FB89-5561-07C1-4CEC-820192004F7C}"/>
          </ac:spMkLst>
        </pc:spChg>
        <pc:spChg chg="del">
          <ac:chgData name="Solenn Tissier" userId="0e0e18d6-263e-426d-a4a8-a62c3d92e241" providerId="ADAL" clId="{F8F8DAE0-6876-4495-8770-31F9B13E4655}" dt="2023-03-18T16:34:04.053" v="222"/>
          <ac:spMkLst>
            <pc:docMk/>
            <pc:sldMk cId="2191617844" sldId="267"/>
            <ac:spMk id="3" creationId="{DABE5D87-CDF2-E001-C50E-2BD53C60E2F0}"/>
          </ac:spMkLst>
        </pc:spChg>
        <pc:spChg chg="add del mod">
          <ac:chgData name="Solenn Tissier" userId="0e0e18d6-263e-426d-a4a8-a62c3d92e241" providerId="ADAL" clId="{F8F8DAE0-6876-4495-8770-31F9B13E4655}" dt="2023-03-18T16:34:47.968" v="228" actId="478"/>
          <ac:spMkLst>
            <pc:docMk/>
            <pc:sldMk cId="2191617844" sldId="267"/>
            <ac:spMk id="6" creationId="{8A8DA1B1-0D08-68C5-1B46-C23B5E990418}"/>
          </ac:spMkLst>
        </pc:spChg>
        <pc:spChg chg="add mod">
          <ac:chgData name="Solenn Tissier" userId="0e0e18d6-263e-426d-a4a8-a62c3d92e241" providerId="ADAL" clId="{F8F8DAE0-6876-4495-8770-31F9B13E4655}" dt="2023-03-18T17:29:11.022" v="1747" actId="1036"/>
          <ac:spMkLst>
            <pc:docMk/>
            <pc:sldMk cId="2191617844" sldId="267"/>
            <ac:spMk id="9" creationId="{FC57CA6B-C3EF-BE74-0A87-4834C4004FF2}"/>
          </ac:spMkLst>
        </pc:spChg>
        <pc:spChg chg="add mod">
          <ac:chgData name="Solenn Tissier" userId="0e0e18d6-263e-426d-a4a8-a62c3d92e241" providerId="ADAL" clId="{F8F8DAE0-6876-4495-8770-31F9B13E4655}" dt="2023-03-18T17:31:10.175" v="1791" actId="1036"/>
          <ac:spMkLst>
            <pc:docMk/>
            <pc:sldMk cId="2191617844" sldId="267"/>
            <ac:spMk id="15" creationId="{1E79E473-B3E1-2BD2-F86E-BD25B69C8F12}"/>
          </ac:spMkLst>
        </pc:spChg>
        <pc:spChg chg="add del mod">
          <ac:chgData name="Solenn Tissier" userId="0e0e18d6-263e-426d-a4a8-a62c3d92e241" providerId="ADAL" clId="{F8F8DAE0-6876-4495-8770-31F9B13E4655}" dt="2023-03-18T16:48:38.024" v="692" actId="478"/>
          <ac:spMkLst>
            <pc:docMk/>
            <pc:sldMk cId="2191617844" sldId="267"/>
            <ac:spMk id="16" creationId="{27AB7A81-D305-5ECC-A1B0-3043DF94B3A4}"/>
          </ac:spMkLst>
        </pc:spChg>
        <pc:spChg chg="add mod">
          <ac:chgData name="Solenn Tissier" userId="0e0e18d6-263e-426d-a4a8-a62c3d92e241" providerId="ADAL" clId="{F8F8DAE0-6876-4495-8770-31F9B13E4655}" dt="2023-03-21T14:11:10.902" v="1839" actId="1037"/>
          <ac:spMkLst>
            <pc:docMk/>
            <pc:sldMk cId="2191617844" sldId="267"/>
            <ac:spMk id="17" creationId="{F336CA20-BFC2-ADEB-DDB2-4AD05C4F4B1D}"/>
          </ac:spMkLst>
        </pc:spChg>
        <pc:grpChg chg="add mod">
          <ac:chgData name="Solenn Tissier" userId="0e0e18d6-263e-426d-a4a8-a62c3d92e241" providerId="ADAL" clId="{F8F8DAE0-6876-4495-8770-31F9B13E4655}" dt="2023-03-18T16:49:33.461" v="698" actId="1076"/>
          <ac:grpSpMkLst>
            <pc:docMk/>
            <pc:sldMk cId="2191617844" sldId="267"/>
            <ac:grpSpMk id="7" creationId="{C174AB77-C89E-4D76-56AF-310492C16F1A}"/>
          </ac:grpSpMkLst>
        </pc:grpChg>
        <pc:graphicFrameChg chg="add del mod">
          <ac:chgData name="Solenn Tissier" userId="0e0e18d6-263e-426d-a4a8-a62c3d92e241" providerId="ADAL" clId="{F8F8DAE0-6876-4495-8770-31F9B13E4655}" dt="2023-03-18T16:34:42.970" v="225" actId="478"/>
          <ac:graphicFrameMkLst>
            <pc:docMk/>
            <pc:sldMk cId="2191617844" sldId="267"/>
            <ac:graphicFrameMk id="4" creationId="{E4089C47-949B-D6BA-E0C8-D2BB541DEBD4}"/>
          </ac:graphicFrameMkLst>
        </pc:graphicFrameChg>
        <pc:graphicFrameChg chg="add mod">
          <ac:chgData name="Solenn Tissier" userId="0e0e18d6-263e-426d-a4a8-a62c3d92e241" providerId="ADAL" clId="{F8F8DAE0-6876-4495-8770-31F9B13E4655}" dt="2023-03-18T16:34:43.856" v="227"/>
          <ac:graphicFrameMkLst>
            <pc:docMk/>
            <pc:sldMk cId="2191617844" sldId="267"/>
            <ac:graphicFrameMk id="8" creationId="{E4089C47-949B-D6BA-E0C8-D2BB541DEBD4}"/>
          </ac:graphicFrameMkLst>
        </pc:graphicFrameChg>
        <pc:picChg chg="add mod">
          <ac:chgData name="Solenn Tissier" userId="0e0e18d6-263e-426d-a4a8-a62c3d92e241" providerId="ADAL" clId="{F8F8DAE0-6876-4495-8770-31F9B13E4655}" dt="2023-03-18T16:49:33.461" v="698" actId="1076"/>
          <ac:picMkLst>
            <pc:docMk/>
            <pc:sldMk cId="2191617844" sldId="267"/>
            <ac:picMk id="11" creationId="{3ADBE0B4-3AD6-312C-24EC-66F4EECCD732}"/>
          </ac:picMkLst>
        </pc:picChg>
        <pc:cxnChg chg="add del mod">
          <ac:chgData name="Solenn Tissier" userId="0e0e18d6-263e-426d-a4a8-a62c3d92e241" providerId="ADAL" clId="{F8F8DAE0-6876-4495-8770-31F9B13E4655}" dt="2023-03-18T16:44:40.913" v="607" actId="478"/>
          <ac:cxnSpMkLst>
            <pc:docMk/>
            <pc:sldMk cId="2191617844" sldId="267"/>
            <ac:cxnSpMk id="13" creationId="{AE9D7F71-9E96-D0E0-4705-9FEF51D2F7BA}"/>
          </ac:cxnSpMkLst>
        </pc:cxnChg>
        <pc:cxnChg chg="add mod">
          <ac:chgData name="Solenn Tissier" userId="0e0e18d6-263e-426d-a4a8-a62c3d92e241" providerId="ADAL" clId="{F8F8DAE0-6876-4495-8770-31F9B13E4655}" dt="2023-03-18T17:32:42.044" v="1814" actId="1038"/>
          <ac:cxnSpMkLst>
            <pc:docMk/>
            <pc:sldMk cId="2191617844" sldId="267"/>
            <ac:cxnSpMk id="14" creationId="{2A06C370-FBDA-1254-D33F-DFFB7BB0614D}"/>
          </ac:cxnSpMkLst>
        </pc:cxnChg>
        <pc:cxnChg chg="add del mod">
          <ac:chgData name="Solenn Tissier" userId="0e0e18d6-263e-426d-a4a8-a62c3d92e241" providerId="ADAL" clId="{F8F8DAE0-6876-4495-8770-31F9B13E4655}" dt="2023-03-18T17:29:39.056" v="1750" actId="478"/>
          <ac:cxnSpMkLst>
            <pc:docMk/>
            <pc:sldMk cId="2191617844" sldId="267"/>
            <ac:cxnSpMk id="18" creationId="{FFE455F7-F135-27A9-12A5-566A3AA1C418}"/>
          </ac:cxnSpMkLst>
        </pc:cxnChg>
      </pc:sldChg>
      <pc:sldChg chg="addSp delSp modSp add mod">
        <pc:chgData name="Solenn Tissier" userId="0e0e18d6-263e-426d-a4a8-a62c3d92e241" providerId="ADAL" clId="{F8F8DAE0-6876-4495-8770-31F9B13E4655}" dt="2023-03-21T19:48:56.769" v="1895" actId="1037"/>
        <pc:sldMkLst>
          <pc:docMk/>
          <pc:sldMk cId="2142438928" sldId="268"/>
        </pc:sldMkLst>
        <pc:spChg chg="add del mod">
          <ac:chgData name="Solenn Tissier" userId="0e0e18d6-263e-426d-a4a8-a62c3d92e241" providerId="ADAL" clId="{F8F8DAE0-6876-4495-8770-31F9B13E4655}" dt="2023-03-18T16:51:55.202" v="776"/>
          <ac:spMkLst>
            <pc:docMk/>
            <pc:sldMk cId="2142438928" sldId="268"/>
            <ac:spMk id="3" creationId="{482769A9-9BAA-4E52-3011-8595AD96B3E5}"/>
          </ac:spMkLst>
        </pc:spChg>
        <pc:spChg chg="mod">
          <ac:chgData name="Solenn Tissier" userId="0e0e18d6-263e-426d-a4a8-a62c3d92e241" providerId="ADAL" clId="{F8F8DAE0-6876-4495-8770-31F9B13E4655}" dt="2023-03-21T19:48:56.769" v="1895" actId="1037"/>
          <ac:spMkLst>
            <pc:docMk/>
            <pc:sldMk cId="2142438928" sldId="268"/>
            <ac:spMk id="8" creationId="{86EFC1D3-A5E4-F763-37F2-C971DF0797BE}"/>
          </ac:spMkLst>
        </pc:spChg>
        <pc:graphicFrameChg chg="add del mod">
          <ac:chgData name="Solenn Tissier" userId="0e0e18d6-263e-426d-a4a8-a62c3d92e241" providerId="ADAL" clId="{F8F8DAE0-6876-4495-8770-31F9B13E4655}" dt="2023-03-18T16:51:54.981" v="775"/>
          <ac:graphicFrameMkLst>
            <pc:docMk/>
            <pc:sldMk cId="2142438928" sldId="268"/>
            <ac:graphicFrameMk id="4" creationId="{8203EFA8-0EE7-3D53-4835-6ACD9B3081D8}"/>
          </ac:graphicFrameMkLst>
        </pc:graphicFrameChg>
        <pc:graphicFrameChg chg="del">
          <ac:chgData name="Solenn Tissier" userId="0e0e18d6-263e-426d-a4a8-a62c3d92e241" providerId="ADAL" clId="{F8F8DAE0-6876-4495-8770-31F9B13E4655}" dt="2023-03-18T16:50:55.779" v="767" actId="478"/>
          <ac:graphicFrameMkLst>
            <pc:docMk/>
            <pc:sldMk cId="2142438928" sldId="268"/>
            <ac:graphicFrameMk id="5" creationId="{603CCFEF-821F-F4DC-8EE3-0D6F709015FD}"/>
          </ac:graphicFrameMkLst>
        </pc:graphicFrameChg>
        <pc:graphicFrameChg chg="add mod modGraphic">
          <ac:chgData name="Solenn Tissier" userId="0e0e18d6-263e-426d-a4a8-a62c3d92e241" providerId="ADAL" clId="{F8F8DAE0-6876-4495-8770-31F9B13E4655}" dt="2023-03-21T19:48:49.272" v="1882" actId="14100"/>
          <ac:graphicFrameMkLst>
            <pc:docMk/>
            <pc:sldMk cId="2142438928" sldId="268"/>
            <ac:graphicFrameMk id="6" creationId="{261A3835-61F4-F7BA-517C-A9F3675BFD91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olen\Downloads\Aires_Activees_QC_11032023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1"/>
          <c:order val="0"/>
          <c:tx>
            <c:v>EE C1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40000"/>
                  <a:lumOff val="60000"/>
                  <a:alpha val="75000"/>
                </a:schemeClr>
              </a:solidFill>
              <a:ln w="9525">
                <a:solidFill>
                  <a:schemeClr val="accent1">
                    <a:lumMod val="40000"/>
                    <a:lumOff val="60000"/>
                  </a:schemeClr>
                </a:solidFill>
              </a:ln>
              <a:effectLst/>
            </c:spPr>
          </c:marker>
          <c:xVal>
            <c:numLit>
              <c:formatCode>General</c:formatCode>
              <c:ptCount val="15"/>
              <c:pt idx="0">
                <c:v>1</c:v>
              </c:pt>
              <c:pt idx="1">
                <c:v>1</c:v>
              </c:pt>
              <c:pt idx="2">
                <c:v>1</c:v>
              </c:pt>
              <c:pt idx="3">
                <c:v>1</c:v>
              </c:pt>
              <c:pt idx="4">
                <c:v>1</c:v>
              </c:pt>
              <c:pt idx="5">
                <c:v>1</c:v>
              </c:pt>
              <c:pt idx="6">
                <c:v>1</c:v>
              </c:pt>
              <c:pt idx="7">
                <c:v>1</c:v>
              </c:pt>
              <c:pt idx="8">
                <c:v>1</c:v>
              </c:pt>
              <c:pt idx="9">
                <c:v>1</c:v>
              </c:pt>
              <c:pt idx="10">
                <c:v>1</c:v>
              </c:pt>
              <c:pt idx="11">
                <c:v>1</c:v>
              </c:pt>
              <c:pt idx="12">
                <c:v>1</c:v>
              </c:pt>
              <c:pt idx="13">
                <c:v>1</c:v>
              </c:pt>
              <c:pt idx="14">
                <c:v>1</c:v>
              </c:pt>
            </c:numLit>
          </c:xVal>
          <c:yVal>
            <c:numRef>
              <c:f>Aire!$BU$1:$BU$4</c:f>
              <c:numCache>
                <c:formatCode>General</c:formatCode>
                <c:ptCount val="4"/>
                <c:pt idx="0">
                  <c:v>3.3239999999999998</c:v>
                </c:pt>
                <c:pt idx="1">
                  <c:v>4.01</c:v>
                </c:pt>
                <c:pt idx="2">
                  <c:v>3.2349999999999999</c:v>
                </c:pt>
                <c:pt idx="3">
                  <c:v>3.88999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089-40D3-A561-A192AA3EC0FC}"/>
            </c:ext>
          </c:extLst>
        </c:ser>
        <c:ser>
          <c:idx val="0"/>
          <c:order val="1"/>
          <c:tx>
            <c:v>EE C2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A7E8FF">
                  <a:alpha val="75000"/>
                </a:srgbClr>
              </a:solidFill>
              <a:ln w="9525">
                <a:solidFill>
                  <a:srgbClr val="A7E8FF"/>
                </a:solidFill>
              </a:ln>
              <a:effectLst/>
            </c:spPr>
          </c:marker>
          <c:xVal>
            <c:numLit>
              <c:formatCode>General</c:formatCode>
              <c:ptCount val="14"/>
              <c:pt idx="0">
                <c:v>1</c:v>
              </c:pt>
              <c:pt idx="1">
                <c:v>1</c:v>
              </c:pt>
              <c:pt idx="2">
                <c:v>1</c:v>
              </c:pt>
              <c:pt idx="3">
                <c:v>1</c:v>
              </c:pt>
              <c:pt idx="4">
                <c:v>1</c:v>
              </c:pt>
              <c:pt idx="5">
                <c:v>1</c:v>
              </c:pt>
              <c:pt idx="6">
                <c:v>1</c:v>
              </c:pt>
              <c:pt idx="7">
                <c:v>1</c:v>
              </c:pt>
              <c:pt idx="8">
                <c:v>1</c:v>
              </c:pt>
              <c:pt idx="9">
                <c:v>1</c:v>
              </c:pt>
              <c:pt idx="10">
                <c:v>1</c:v>
              </c:pt>
              <c:pt idx="11">
                <c:v>1</c:v>
              </c:pt>
              <c:pt idx="12">
                <c:v>1</c:v>
              </c:pt>
              <c:pt idx="13">
                <c:v>1</c:v>
              </c:pt>
            </c:numLit>
          </c:xVal>
          <c:yVal>
            <c:numRef>
              <c:f>Aire!$BU$5:$BU$8</c:f>
              <c:numCache>
                <c:formatCode>General</c:formatCode>
                <c:ptCount val="4"/>
                <c:pt idx="0">
                  <c:v>4.32</c:v>
                </c:pt>
                <c:pt idx="1">
                  <c:v>4.13</c:v>
                </c:pt>
                <c:pt idx="2">
                  <c:v>3.4699999999999998</c:v>
                </c:pt>
                <c:pt idx="3">
                  <c:v>4.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089-40D3-A561-A192AA3EC0FC}"/>
            </c:ext>
          </c:extLst>
        </c:ser>
        <c:ser>
          <c:idx val="2"/>
          <c:order val="2"/>
          <c:tx>
            <c:v>EE C3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2">
                  <a:lumMod val="40000"/>
                  <a:lumOff val="60000"/>
                  <a:alpha val="75000"/>
                </a:schemeClr>
              </a:solidFill>
              <a:ln w="9525">
                <a:solidFill>
                  <a:schemeClr val="tx2">
                    <a:lumMod val="40000"/>
                    <a:lumOff val="60000"/>
                  </a:schemeClr>
                </a:solidFill>
              </a:ln>
              <a:effectLst/>
            </c:spPr>
          </c:marker>
          <c:xVal>
            <c:numLit>
              <c:formatCode>General</c:formatCode>
              <c:ptCount val="19"/>
              <c:pt idx="0">
                <c:v>1</c:v>
              </c:pt>
              <c:pt idx="1">
                <c:v>1</c:v>
              </c:pt>
              <c:pt idx="2">
                <c:v>1</c:v>
              </c:pt>
              <c:pt idx="3">
                <c:v>1</c:v>
              </c:pt>
              <c:pt idx="4">
                <c:v>1</c:v>
              </c:pt>
              <c:pt idx="5">
                <c:v>1</c:v>
              </c:pt>
              <c:pt idx="6">
                <c:v>1</c:v>
              </c:pt>
              <c:pt idx="7">
                <c:v>1</c:v>
              </c:pt>
              <c:pt idx="8">
                <c:v>1</c:v>
              </c:pt>
              <c:pt idx="9">
                <c:v>1</c:v>
              </c:pt>
              <c:pt idx="10">
                <c:v>1</c:v>
              </c:pt>
              <c:pt idx="11">
                <c:v>1</c:v>
              </c:pt>
              <c:pt idx="12">
                <c:v>1</c:v>
              </c:pt>
              <c:pt idx="13">
                <c:v>1</c:v>
              </c:pt>
              <c:pt idx="14">
                <c:v>1</c:v>
              </c:pt>
              <c:pt idx="15">
                <c:v>1</c:v>
              </c:pt>
              <c:pt idx="16">
                <c:v>1</c:v>
              </c:pt>
              <c:pt idx="17">
                <c:v>1</c:v>
              </c:pt>
              <c:pt idx="18">
                <c:v>1</c:v>
              </c:pt>
            </c:numLit>
          </c:xVal>
          <c:yVal>
            <c:numRef>
              <c:f>Aire!$BU$9:$BU$16</c:f>
              <c:numCache>
                <c:formatCode>General</c:formatCode>
                <c:ptCount val="8"/>
                <c:pt idx="0">
                  <c:v>4.01</c:v>
                </c:pt>
                <c:pt idx="1">
                  <c:v>4.2460000000000004</c:v>
                </c:pt>
                <c:pt idx="2">
                  <c:v>3.9099999999999997</c:v>
                </c:pt>
                <c:pt idx="3">
                  <c:v>4.03</c:v>
                </c:pt>
                <c:pt idx="4">
                  <c:v>4.26</c:v>
                </c:pt>
                <c:pt idx="5">
                  <c:v>4.09</c:v>
                </c:pt>
                <c:pt idx="6">
                  <c:v>3.17</c:v>
                </c:pt>
                <c:pt idx="7">
                  <c:v>3.4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089-40D3-A561-A192AA3EC0FC}"/>
            </c:ext>
          </c:extLst>
        </c:ser>
        <c:ser>
          <c:idx val="3"/>
          <c:order val="3"/>
          <c:tx>
            <c:v>ST C1</c:v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accent4">
                  <a:lumMod val="40000"/>
                  <a:lumOff val="60000"/>
                  <a:alpha val="75000"/>
                </a:schemeClr>
              </a:solidFill>
              <a:ln w="9525">
                <a:solidFill>
                  <a:schemeClr val="accent4">
                    <a:lumMod val="40000"/>
                    <a:lumOff val="60000"/>
                  </a:schemeClr>
                </a:solidFill>
              </a:ln>
              <a:effectLst/>
            </c:spPr>
          </c:marker>
          <c:xVal>
            <c:numLit>
              <c:formatCode>General</c:formatCode>
              <c:ptCount val="8"/>
              <c:pt idx="0">
                <c:v>0.5</c:v>
              </c:pt>
              <c:pt idx="1">
                <c:v>0.5</c:v>
              </c:pt>
              <c:pt idx="2">
                <c:v>0.5</c:v>
              </c:pt>
              <c:pt idx="3">
                <c:v>0.5</c:v>
              </c:pt>
              <c:pt idx="4">
                <c:v>0.5</c:v>
              </c:pt>
              <c:pt idx="5">
                <c:v>0.5</c:v>
              </c:pt>
              <c:pt idx="6">
                <c:v>0.5</c:v>
              </c:pt>
              <c:pt idx="7">
                <c:v>0.5</c:v>
              </c:pt>
            </c:numLit>
          </c:xVal>
          <c:yVal>
            <c:numRef>
              <c:f>Aire!$BU$17:$BU$19</c:f>
              <c:numCache>
                <c:formatCode>General</c:formatCode>
                <c:ptCount val="3"/>
                <c:pt idx="0">
                  <c:v>3.18</c:v>
                </c:pt>
                <c:pt idx="1">
                  <c:v>3.99</c:v>
                </c:pt>
                <c:pt idx="2">
                  <c:v>2.6500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089-40D3-A561-A192AA3EC0FC}"/>
            </c:ext>
          </c:extLst>
        </c:ser>
        <c:ser>
          <c:idx val="4"/>
          <c:order val="4"/>
          <c:tx>
            <c:v>ST C2</c:v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accent6">
                  <a:lumMod val="40000"/>
                  <a:lumOff val="60000"/>
                  <a:alpha val="75000"/>
                </a:schemeClr>
              </a:solidFill>
              <a:ln w="9525">
                <a:solidFill>
                  <a:schemeClr val="accent6">
                    <a:lumMod val="40000"/>
                    <a:lumOff val="60000"/>
                  </a:schemeClr>
                </a:solidFill>
              </a:ln>
              <a:effectLst/>
            </c:spPr>
          </c:marker>
          <c:xVal>
            <c:numLit>
              <c:formatCode>General</c:formatCode>
              <c:ptCount val="8"/>
              <c:pt idx="0">
                <c:v>0.5</c:v>
              </c:pt>
              <c:pt idx="1">
                <c:v>0.5</c:v>
              </c:pt>
              <c:pt idx="2">
                <c:v>0.5</c:v>
              </c:pt>
              <c:pt idx="3">
                <c:v>0.5</c:v>
              </c:pt>
              <c:pt idx="4">
                <c:v>0.5</c:v>
              </c:pt>
              <c:pt idx="5">
                <c:v>0.5</c:v>
              </c:pt>
              <c:pt idx="6">
                <c:v>0.5</c:v>
              </c:pt>
              <c:pt idx="7">
                <c:v>0.5</c:v>
              </c:pt>
            </c:numLit>
          </c:xVal>
          <c:yVal>
            <c:numRef>
              <c:f>Aire!$BU$20:$BU$23</c:f>
              <c:numCache>
                <c:formatCode>General</c:formatCode>
                <c:ptCount val="4"/>
                <c:pt idx="0">
                  <c:v>3.0599999999999996</c:v>
                </c:pt>
                <c:pt idx="1">
                  <c:v>3.88</c:v>
                </c:pt>
                <c:pt idx="2">
                  <c:v>3.39</c:v>
                </c:pt>
                <c:pt idx="3">
                  <c:v>4.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9089-40D3-A561-A192AA3EC0FC}"/>
            </c:ext>
          </c:extLst>
        </c:ser>
        <c:ser>
          <c:idx val="5"/>
          <c:order val="5"/>
          <c:tx>
            <c:v>ST C3</c:v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accent2">
                  <a:lumMod val="40000"/>
                  <a:lumOff val="60000"/>
                  <a:alpha val="75000"/>
                </a:schemeClr>
              </a:solidFill>
              <a:ln w="9525">
                <a:solidFill>
                  <a:schemeClr val="accent2">
                    <a:lumMod val="40000"/>
                    <a:lumOff val="60000"/>
                  </a:schemeClr>
                </a:solidFill>
              </a:ln>
              <a:effectLst/>
            </c:spPr>
          </c:marker>
          <c:xVal>
            <c:numLit>
              <c:formatCode>General</c:formatCode>
              <c:ptCount val="8"/>
              <c:pt idx="0">
                <c:v>0.5</c:v>
              </c:pt>
              <c:pt idx="1">
                <c:v>0.5</c:v>
              </c:pt>
              <c:pt idx="2">
                <c:v>0.5</c:v>
              </c:pt>
              <c:pt idx="3">
                <c:v>0.5</c:v>
              </c:pt>
              <c:pt idx="4">
                <c:v>0.5</c:v>
              </c:pt>
              <c:pt idx="5">
                <c:v>0.5</c:v>
              </c:pt>
              <c:pt idx="6">
                <c:v>0.5</c:v>
              </c:pt>
              <c:pt idx="7">
                <c:v>0.5</c:v>
              </c:pt>
            </c:numLit>
          </c:xVal>
          <c:yVal>
            <c:numRef>
              <c:f>Aire!$BU$24:$BU$28</c:f>
              <c:numCache>
                <c:formatCode>General</c:formatCode>
                <c:ptCount val="5"/>
                <c:pt idx="0">
                  <c:v>3.29</c:v>
                </c:pt>
                <c:pt idx="1">
                  <c:v>3.42</c:v>
                </c:pt>
                <c:pt idx="2">
                  <c:v>2.59</c:v>
                </c:pt>
                <c:pt idx="3">
                  <c:v>4.13</c:v>
                </c:pt>
                <c:pt idx="4">
                  <c:v>2.9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9089-40D3-A561-A192AA3EC0FC}"/>
            </c:ext>
          </c:extLst>
        </c:ser>
        <c:ser>
          <c:idx val="12"/>
          <c:order val="12"/>
          <c:tx>
            <c:v>Average EE</c:v>
          </c:tx>
          <c:spPr>
            <a:ln w="25400" cap="rnd">
              <a:noFill/>
              <a:round/>
            </a:ln>
            <a:effectLst/>
          </c:spPr>
          <c:marker>
            <c:symbol val="dash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Lit>
              <c:formatCode>General</c:formatCode>
              <c:ptCount val="1"/>
              <c:pt idx="0">
                <c:v>1</c:v>
              </c:pt>
            </c:numLit>
          </c:xVal>
          <c:yVal>
            <c:numRef>
              <c:f>Aire!$BN$37</c:f>
              <c:numCache>
                <c:formatCode>General</c:formatCode>
                <c:ptCount val="1"/>
                <c:pt idx="0">
                  <c:v>3.8603124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9089-40D3-A561-A192AA3EC0FC}"/>
            </c:ext>
          </c:extLst>
        </c:ser>
        <c:ser>
          <c:idx val="13"/>
          <c:order val="13"/>
          <c:tx>
            <c:v>Average ST</c:v>
          </c:tx>
          <c:spPr>
            <a:ln w="25400" cap="rnd">
              <a:noFill/>
              <a:round/>
            </a:ln>
            <a:effectLst/>
          </c:spPr>
          <c:marker>
            <c:symbol val="dash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Lit>
              <c:formatCode>General</c:formatCode>
              <c:ptCount val="1"/>
              <c:pt idx="0">
                <c:v>0.5</c:v>
              </c:pt>
            </c:numLit>
          </c:xVal>
          <c:yVal>
            <c:numRef>
              <c:f>Aire!$BN$38</c:f>
              <c:numCache>
                <c:formatCode>General</c:formatCode>
                <c:ptCount val="1"/>
                <c:pt idx="0">
                  <c:v>3.38166666666666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9089-40D3-A561-A192AA3EC0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67941087"/>
        <c:axId val="1780862079"/>
        <c:extLst>
          <c:ext xmlns:c15="http://schemas.microsoft.com/office/drawing/2012/chart" uri="{02D57815-91ED-43cb-92C2-25804820EDAC}">
            <c15:filteredScatterSeries>
              <c15:ser>
                <c:idx val="6"/>
                <c:order val="6"/>
                <c:tx>
                  <c:v>Mean EE C1</c:v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ash"/>
                  <c:size val="10"/>
                  <c:spPr>
                    <a:solidFill>
                      <a:schemeClr val="accent1">
                        <a:lumMod val="40000"/>
                        <a:lumOff val="60000"/>
                        <a:alpha val="75000"/>
                      </a:schemeClr>
                    </a:solidFill>
                    <a:ln w="9525">
                      <a:solidFill>
                        <a:schemeClr val="accent1">
                          <a:lumMod val="40000"/>
                          <a:lumOff val="60000"/>
                        </a:schemeClr>
                      </a:solidFill>
                    </a:ln>
                    <a:effectLst/>
                  </c:spPr>
                </c:marker>
                <c:xVal>
                  <c:numLit>
                    <c:formatCode>General</c:formatCode>
                    <c:ptCount val="1"/>
                    <c:pt idx="0">
                      <c:v>1</c:v>
                    </c:pt>
                  </c:numLit>
                </c:xVal>
                <c:yVal>
                  <c:numRef>
                    <c:extLst>
                      <c:ext uri="{02D57815-91ED-43cb-92C2-25804820EDAC}">
                        <c15:formulaRef>
                          <c15:sqref>Aire!$BX$3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3.6150000000000002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08-9089-40D3-A561-A192AA3EC0FC}"/>
                  </c:ext>
                </c:extLst>
              </c15:ser>
            </c15:filteredScatterSeries>
            <c15:filteredScatterSeries>
              <c15:ser>
                <c:idx val="7"/>
                <c:order val="7"/>
                <c:tx>
                  <c:v>Mean EE C2</c:v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ash"/>
                  <c:size val="10"/>
                  <c:spPr>
                    <a:solidFill>
                      <a:srgbClr val="A7E8FF">
                        <a:alpha val="75000"/>
                      </a:srgbClr>
                    </a:solidFill>
                    <a:ln w="9525">
                      <a:solidFill>
                        <a:srgbClr val="A7E8FF"/>
                      </a:solidFill>
                    </a:ln>
                    <a:effectLst/>
                  </c:spPr>
                </c:marker>
                <c:xVal>
                  <c:numLit>
                    <c:formatCode>General</c:formatCode>
                    <c:ptCount val="1"/>
                    <c:pt idx="0">
                      <c:v>1</c:v>
                    </c:pt>
                  </c:numLit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Aire!$BX$4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4.033000000000000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9-9089-40D3-A561-A192AA3EC0FC}"/>
                  </c:ext>
                </c:extLst>
              </c15:ser>
            </c15:filteredScatterSeries>
            <c15:filteredScatterSeries>
              <c15:ser>
                <c:idx val="9"/>
                <c:order val="8"/>
                <c:tx>
                  <c:v>Mean EE C3</c:v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ash"/>
                  <c:size val="10"/>
                  <c:spPr>
                    <a:solidFill>
                      <a:schemeClr val="tx2">
                        <a:lumMod val="40000"/>
                        <a:lumOff val="60000"/>
                      </a:schemeClr>
                    </a:solidFill>
                    <a:ln w="9525">
                      <a:solidFill>
                        <a:schemeClr val="tx2">
                          <a:lumMod val="40000"/>
                          <a:lumOff val="60000"/>
                        </a:schemeClr>
                      </a:solidFill>
                    </a:ln>
                    <a:effectLst/>
                  </c:spPr>
                </c:marker>
                <c:xVal>
                  <c:numLit>
                    <c:formatCode>General</c:formatCode>
                    <c:ptCount val="1"/>
                    <c:pt idx="0">
                      <c:v>1</c:v>
                    </c:pt>
                  </c:numLit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Aire!$BX$5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3.897000000000000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A-9089-40D3-A561-A192AA3EC0FC}"/>
                  </c:ext>
                </c:extLst>
              </c15:ser>
            </c15:filteredScatterSeries>
            <c15:filteredScatterSeries>
              <c15:ser>
                <c:idx val="10"/>
                <c:order val="9"/>
                <c:tx>
                  <c:v>Mean ST C1</c:v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ash"/>
                  <c:size val="10"/>
                  <c:spPr>
                    <a:solidFill>
                      <a:schemeClr val="accent4">
                        <a:lumMod val="40000"/>
                        <a:lumOff val="60000"/>
                        <a:alpha val="75000"/>
                      </a:schemeClr>
                    </a:solidFill>
                    <a:ln w="9525">
                      <a:solidFill>
                        <a:schemeClr val="accent4">
                          <a:lumMod val="40000"/>
                          <a:lumOff val="60000"/>
                        </a:schemeClr>
                      </a:solidFill>
                    </a:ln>
                    <a:effectLst/>
                  </c:spPr>
                </c:marker>
                <c:dPt>
                  <c:idx val="0"/>
                  <c:marker>
                    <c:symbol val="dash"/>
                    <c:size val="10"/>
                    <c:spPr>
                      <a:solidFill>
                        <a:schemeClr val="accent4">
                          <a:lumMod val="40000"/>
                          <a:lumOff val="60000"/>
                          <a:alpha val="75000"/>
                        </a:schemeClr>
                      </a:solidFill>
                      <a:ln w="9525">
                        <a:solidFill>
                          <a:schemeClr val="accent4">
                            <a:lumMod val="40000"/>
                            <a:lumOff val="60000"/>
                          </a:schemeClr>
                        </a:solidFill>
                      </a:ln>
                      <a:effectLst/>
                    </c:spPr>
                  </c:marker>
                  <c:bubble3D val="0"/>
                  <c:spPr>
                    <a:ln w="25400" cap="rnd">
                      <a:noFill/>
                      <a:round/>
                    </a:ln>
                    <a:effectLst/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0C-9089-40D3-A561-A192AA3EC0FC}"/>
                    </c:ext>
                  </c:extLst>
                </c:dPt>
                <c:xVal>
                  <c:numLit>
                    <c:formatCode>General</c:formatCode>
                    <c:ptCount val="1"/>
                    <c:pt idx="0">
                      <c:v>0.5</c:v>
                    </c:pt>
                  </c:numLit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Aire!$BX$8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3.273000000000000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D-9089-40D3-A561-A192AA3EC0FC}"/>
                  </c:ext>
                </c:extLst>
              </c15:ser>
            </c15:filteredScatterSeries>
            <c15:filteredScatterSeries>
              <c15:ser>
                <c:idx val="11"/>
                <c:order val="10"/>
                <c:tx>
                  <c:v>Mean ST C2</c:v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ash"/>
                  <c:size val="10"/>
                  <c:spPr>
                    <a:solidFill>
                      <a:schemeClr val="accent6">
                        <a:lumMod val="40000"/>
                        <a:lumOff val="60000"/>
                        <a:alpha val="75000"/>
                      </a:schemeClr>
                    </a:solidFill>
                    <a:ln w="9525">
                      <a:solidFill>
                        <a:schemeClr val="accent6">
                          <a:lumMod val="40000"/>
                          <a:lumOff val="60000"/>
                        </a:schemeClr>
                      </a:solidFill>
                    </a:ln>
                    <a:effectLst/>
                  </c:spPr>
                </c:marker>
                <c:xVal>
                  <c:numLit>
                    <c:formatCode>General</c:formatCode>
                    <c:ptCount val="1"/>
                    <c:pt idx="0">
                      <c:v>0.5</c:v>
                    </c:pt>
                  </c:numLit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Aire!$BX$9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3.60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E-9089-40D3-A561-A192AA3EC0FC}"/>
                  </c:ext>
                </c:extLst>
              </c15:ser>
            </c15:filteredScatterSeries>
            <c15:filteredScatterSeries>
              <c15:ser>
                <c:idx val="8"/>
                <c:order val="11"/>
                <c:tx>
                  <c:v>Mean ST C3</c:v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ash"/>
                  <c:size val="10"/>
                  <c:spPr>
                    <a:solidFill>
                      <a:schemeClr val="accent2">
                        <a:lumMod val="40000"/>
                        <a:lumOff val="60000"/>
                        <a:alpha val="75000"/>
                      </a:schemeClr>
                    </a:solidFill>
                    <a:ln w="9525">
                      <a:solidFill>
                        <a:schemeClr val="accent2">
                          <a:lumMod val="40000"/>
                          <a:lumOff val="60000"/>
                        </a:schemeClr>
                      </a:solidFill>
                    </a:ln>
                    <a:effectLst/>
                  </c:spPr>
                </c:marker>
                <c:xVal>
                  <c:numLit>
                    <c:formatCode>General</c:formatCode>
                    <c:ptCount val="1"/>
                    <c:pt idx="0">
                      <c:v>0.5</c:v>
                    </c:pt>
                  </c:numLit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Aire!$BX$10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3.267999999999999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F-9089-40D3-A561-A192AA3EC0FC}"/>
                  </c:ext>
                </c:extLst>
              </c15:ser>
            </c15:filteredScatterSeries>
          </c:ext>
        </c:extLst>
      </c:scatterChart>
      <c:valAx>
        <c:axId val="1667941087"/>
        <c:scaling>
          <c:orientation val="minMax"/>
          <c:max val="1.5"/>
          <c:min val="0"/>
        </c:scaling>
        <c:delete val="1"/>
        <c:axPos val="b"/>
        <c:numFmt formatCode="General" sourceLinked="1"/>
        <c:majorTickMark val="none"/>
        <c:minorTickMark val="none"/>
        <c:tickLblPos val="nextTo"/>
        <c:crossAx val="1780862079"/>
        <c:crosses val="autoZero"/>
        <c:crossBetween val="midCat"/>
        <c:majorUnit val="0.5"/>
      </c:valAx>
      <c:valAx>
        <c:axId val="1780862079"/>
        <c:scaling>
          <c:orientation val="minMax"/>
          <c:min val="2.5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67941087"/>
        <c:crosses val="autoZero"/>
        <c:crossBetween val="midCat"/>
        <c:majorUnit val="0.2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3207</cdr:x>
      <cdr:y>0.91974</cdr:y>
    </cdr:from>
    <cdr:to>
      <cdr:x>0.86784</cdr:x>
      <cdr:y>0.99408</cdr:y>
    </cdr:to>
    <cdr:sp macro="" textlink="">
      <cdr:nvSpPr>
        <cdr:cNvPr id="2" name="TextBox 13">
          <a:extLst xmlns:a="http://schemas.openxmlformats.org/drawingml/2006/main">
            <a:ext uri="{FF2B5EF4-FFF2-40B4-BE49-F238E27FC236}">
              <a16:creationId xmlns:a16="http://schemas.microsoft.com/office/drawing/2014/main" id="{FC57CA6B-C3EF-BE74-0A87-4834C4004FF2}"/>
            </a:ext>
          </a:extLst>
        </cdr:cNvPr>
        <cdr:cNvSpPr txBox="1"/>
      </cdr:nvSpPr>
      <cdr:spPr>
        <a:xfrm xmlns:a="http://schemas.openxmlformats.org/drawingml/2006/main">
          <a:off x="2196582" y="2324794"/>
          <a:ext cx="819355" cy="187907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CA" sz="1100" dirty="0"/>
            <a:t>EE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3BB06-4F81-4145-BD4E-88E81B8B3A03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20974-C55F-3E47-BD1D-189FCF6583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4500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3BB06-4F81-4145-BD4E-88E81B8B3A03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20974-C55F-3E47-BD1D-189FCF6583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358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3BB06-4F81-4145-BD4E-88E81B8B3A03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20974-C55F-3E47-BD1D-189FCF6583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677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3BB06-4F81-4145-BD4E-88E81B8B3A03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20974-C55F-3E47-BD1D-189FCF6583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148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3BB06-4F81-4145-BD4E-88E81B8B3A03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20974-C55F-3E47-BD1D-189FCF6583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3625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3BB06-4F81-4145-BD4E-88E81B8B3A03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20974-C55F-3E47-BD1D-189FCF6583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5788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3BB06-4F81-4145-BD4E-88E81B8B3A03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20974-C55F-3E47-BD1D-189FCF6583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4550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3BB06-4F81-4145-BD4E-88E81B8B3A03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20974-C55F-3E47-BD1D-189FCF6583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818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3BB06-4F81-4145-BD4E-88E81B8B3A03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20974-C55F-3E47-BD1D-189FCF6583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4462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3BB06-4F81-4145-BD4E-88E81B8B3A03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20974-C55F-3E47-BD1D-189FCF6583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539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3BB06-4F81-4145-BD4E-88E81B8B3A03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20974-C55F-3E47-BD1D-189FCF6583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6269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F3BB06-4F81-4145-BD4E-88E81B8B3A03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A20974-C55F-3E47-BD1D-189FCF6583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9180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4AC4FA45-1F8C-0377-CDE7-2710320A786B}"/>
              </a:ext>
            </a:extLst>
          </p:cNvPr>
          <p:cNvSpPr txBox="1"/>
          <p:nvPr/>
        </p:nvSpPr>
        <p:spPr>
          <a:xfrm>
            <a:off x="742405" y="1435129"/>
            <a:ext cx="5373189" cy="39172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b="0" i="0" dirty="0">
                <a:solidFill>
                  <a:srgbClr val="222222"/>
                </a:solidFill>
                <a:effectLst/>
                <a:latin typeface="-apple-system"/>
              </a:rPr>
              <a:t>Supplementary Information file</a:t>
            </a:r>
          </a:p>
          <a:p>
            <a:endParaRPr lang="en-CA" dirty="0">
              <a:solidFill>
                <a:srgbClr val="222222"/>
              </a:solidFill>
              <a:latin typeface="-apple-system"/>
            </a:endParaRPr>
          </a:p>
          <a:p>
            <a:endParaRPr lang="en-CA" dirty="0">
              <a:solidFill>
                <a:srgbClr val="222222"/>
              </a:solidFill>
              <a:latin typeface="-apple-system"/>
            </a:endParaRPr>
          </a:p>
          <a:p>
            <a:endParaRPr lang="en-CA" dirty="0">
              <a:solidFill>
                <a:srgbClr val="222222"/>
              </a:solidFill>
              <a:latin typeface="-apple-system"/>
            </a:endParaRPr>
          </a:p>
          <a:p>
            <a:endParaRPr lang="en-CA" b="0" i="0" dirty="0">
              <a:solidFill>
                <a:srgbClr val="222222"/>
              </a:solidFill>
              <a:effectLst/>
              <a:latin typeface="-apple-system"/>
            </a:endParaRPr>
          </a:p>
          <a:p>
            <a:pPr algn="ctr">
              <a:lnSpc>
                <a:spcPct val="107000"/>
              </a:lnSpc>
              <a:spcAft>
                <a:spcPts val="1000"/>
              </a:spcAft>
            </a:pPr>
            <a:r>
              <a:rPr lang="en-CA" sz="1800" b="1" dirty="0">
                <a:effectLst/>
                <a:latin typeface="Calibri" panose="020F050202020403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Enriched Environment Exposure during Development Positively Impacts the Structure and Function of the Visual Cortex in Mice</a:t>
            </a:r>
            <a:endParaRPr lang="en-CA" sz="1800" dirty="0">
              <a:effectLst/>
              <a:latin typeface="Cambria" panose="02040503050406030204" pitchFamily="18" charset="0"/>
              <a:ea typeface="Cambria" panose="020405030504060302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1000"/>
              </a:spcAft>
            </a:pPr>
            <a:r>
              <a:rPr lang="en-CA" sz="1800" dirty="0">
                <a:effectLst/>
                <a:latin typeface="Calibri" panose="020F050202020403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 </a:t>
            </a:r>
            <a:endParaRPr lang="en-CA" sz="1800" dirty="0">
              <a:effectLst/>
              <a:latin typeface="Cambria" panose="02040503050406030204" pitchFamily="18" charset="0"/>
              <a:ea typeface="Cambria" panose="020405030504060302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1000"/>
              </a:spcAft>
            </a:pPr>
            <a:r>
              <a:rPr lang="fr-CA" sz="1800" b="1" dirty="0">
                <a:effectLst/>
                <a:latin typeface="Calibri" panose="020F050202020403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O. Bibollet-Bahena, S. Tissier, S. Ho-</a:t>
            </a:r>
            <a:r>
              <a:rPr lang="fr-CA" sz="1800" b="1" dirty="0" err="1">
                <a:effectLst/>
                <a:latin typeface="Calibri" panose="020F050202020403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Tran</a:t>
            </a:r>
            <a:r>
              <a:rPr lang="fr-CA" sz="1800" b="1" dirty="0">
                <a:effectLst/>
                <a:latin typeface="Calibri" panose="020F050202020403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, A. </a:t>
            </a:r>
            <a:r>
              <a:rPr lang="fr-CA" sz="1800" b="1" dirty="0" err="1">
                <a:effectLst/>
                <a:latin typeface="Calibri" panose="020F050202020403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Rojewski</a:t>
            </a:r>
            <a:r>
              <a:rPr lang="fr-CA" sz="1800" b="1" dirty="0">
                <a:effectLst/>
                <a:latin typeface="Calibri" panose="020F050202020403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, C. Casanova. </a:t>
            </a:r>
            <a:endParaRPr lang="en-CA" sz="1800" dirty="0">
              <a:effectLst/>
              <a:latin typeface="Cambria" panose="02040503050406030204" pitchFamily="18" charset="0"/>
              <a:ea typeface="Cambria" panose="02040503050406030204" pitchFamily="18" charset="0"/>
              <a:cs typeface="Times New Roman" panose="02020603050405020304" pitchFamily="18" charset="0"/>
            </a:endParaRPr>
          </a:p>
          <a:p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6118501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9" t="11239" r="2975" b="11401"/>
          <a:stretch/>
        </p:blipFill>
        <p:spPr>
          <a:xfrm>
            <a:off x="3231366" y="896185"/>
            <a:ext cx="1562859" cy="965402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973696" y="465273"/>
            <a:ext cx="1743855" cy="2325139"/>
          </a:xfrm>
          <a:prstGeom prst="rect">
            <a:avLst/>
          </a:prstGeom>
        </p:spPr>
      </p:pic>
      <p:sp>
        <p:nvSpPr>
          <p:cNvPr id="6" name="ZoneTexte 77"/>
          <p:cNvSpPr txBox="1"/>
          <p:nvPr/>
        </p:nvSpPr>
        <p:spPr>
          <a:xfrm>
            <a:off x="538416" y="510510"/>
            <a:ext cx="1446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600" b="1" dirty="0"/>
              <a:t>A</a:t>
            </a:r>
          </a:p>
        </p:txBody>
      </p:sp>
      <p:sp>
        <p:nvSpPr>
          <p:cNvPr id="7" name="ZoneTexte 77"/>
          <p:cNvSpPr txBox="1"/>
          <p:nvPr/>
        </p:nvSpPr>
        <p:spPr>
          <a:xfrm>
            <a:off x="3008193" y="510510"/>
            <a:ext cx="1446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600" b="1" dirty="0"/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38415" y="3942798"/>
            <a:ext cx="576804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S1.</a:t>
            </a:r>
          </a:p>
          <a:p>
            <a:endParaRPr lang="en-US" sz="1200" dirty="0"/>
          </a:p>
          <a:p>
            <a:r>
              <a:rPr lang="en-US" sz="1200" dirty="0"/>
              <a:t>Enriched (50 x 38 x 20 cm; A) and standard (30 x 19 x 12.5 cm; B) housing experimental procedure. The bottom of the cages is shown in the actual proportions of the two environments. 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52428221-F977-E9D0-8837-6013F1909528}"/>
              </a:ext>
            </a:extLst>
          </p:cNvPr>
          <p:cNvCxnSpPr>
            <a:cxnSpLocks/>
          </p:cNvCxnSpPr>
          <p:nvPr/>
        </p:nvCxnSpPr>
        <p:spPr>
          <a:xfrm>
            <a:off x="683053" y="2584904"/>
            <a:ext cx="349200" cy="0"/>
          </a:xfrm>
          <a:prstGeom prst="line">
            <a:avLst/>
          </a:prstGeom>
          <a:ln w="3810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F568109A-3D90-3B35-51EC-26CA4F2706F0}"/>
              </a:ext>
            </a:extLst>
          </p:cNvPr>
          <p:cNvSpPr txBox="1"/>
          <p:nvPr/>
        </p:nvSpPr>
        <p:spPr>
          <a:xfrm>
            <a:off x="633425" y="2584904"/>
            <a:ext cx="450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/>
              <a:t>10 cm</a:t>
            </a:r>
          </a:p>
        </p:txBody>
      </p:sp>
    </p:spTree>
    <p:extLst>
      <p:ext uri="{BB962C8B-B14F-4D97-AF65-F5344CB8AC3E}">
        <p14:creationId xmlns:p14="http://schemas.microsoft.com/office/powerpoint/2010/main" val="3159890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603CCFEF-821F-F4DC-8EE3-0D6F709015F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09769511"/>
              </p:ext>
            </p:extLst>
          </p:nvPr>
        </p:nvGraphicFramePr>
        <p:xfrm>
          <a:off x="953589" y="1610016"/>
          <a:ext cx="4759232" cy="896620"/>
        </p:xfrm>
        <a:graphic>
          <a:graphicData uri="http://schemas.openxmlformats.org/drawingml/2006/table">
            <a:tbl>
              <a:tblPr/>
              <a:tblGrid>
                <a:gridCol w="1040674">
                  <a:extLst>
                    <a:ext uri="{9D8B030D-6E8A-4147-A177-3AD203B41FA5}">
                      <a16:colId xmlns:a16="http://schemas.microsoft.com/office/drawing/2014/main" val="3691090383"/>
                    </a:ext>
                  </a:extLst>
                </a:gridCol>
                <a:gridCol w="513806">
                  <a:extLst>
                    <a:ext uri="{9D8B030D-6E8A-4147-A177-3AD203B41FA5}">
                      <a16:colId xmlns:a16="http://schemas.microsoft.com/office/drawing/2014/main" val="2076690746"/>
                    </a:ext>
                  </a:extLst>
                </a:gridCol>
                <a:gridCol w="531222">
                  <a:extLst>
                    <a:ext uri="{9D8B030D-6E8A-4147-A177-3AD203B41FA5}">
                      <a16:colId xmlns:a16="http://schemas.microsoft.com/office/drawing/2014/main" val="855300905"/>
                    </a:ext>
                  </a:extLst>
                </a:gridCol>
                <a:gridCol w="714485">
                  <a:extLst>
                    <a:ext uri="{9D8B030D-6E8A-4147-A177-3AD203B41FA5}">
                      <a16:colId xmlns:a16="http://schemas.microsoft.com/office/drawing/2014/main" val="2352554636"/>
                    </a:ext>
                  </a:extLst>
                </a:gridCol>
                <a:gridCol w="521446">
                  <a:extLst>
                    <a:ext uri="{9D8B030D-6E8A-4147-A177-3AD203B41FA5}">
                      <a16:colId xmlns:a16="http://schemas.microsoft.com/office/drawing/2014/main" val="256387044"/>
                    </a:ext>
                  </a:extLst>
                </a:gridCol>
                <a:gridCol w="716989">
                  <a:extLst>
                    <a:ext uri="{9D8B030D-6E8A-4147-A177-3AD203B41FA5}">
                      <a16:colId xmlns:a16="http://schemas.microsoft.com/office/drawing/2014/main" val="2557679222"/>
                    </a:ext>
                  </a:extLst>
                </a:gridCol>
                <a:gridCol w="720610">
                  <a:extLst>
                    <a:ext uri="{9D8B030D-6E8A-4147-A177-3AD203B41FA5}">
                      <a16:colId xmlns:a16="http://schemas.microsoft.com/office/drawing/2014/main" val="1201772612"/>
                    </a:ext>
                  </a:extLst>
                </a:gridCol>
              </a:tblGrid>
              <a:tr h="1587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 Deviation</a:t>
                      </a: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der</a:t>
                      </a: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en-C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 Deviation</a:t>
                      </a:r>
                      <a:endParaRPr lang="en-C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9824497"/>
                  </a:ext>
                </a:extLst>
              </a:tr>
              <a:tr h="1803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ight</a:t>
                      </a: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</a:t>
                      </a: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.91 g</a:t>
                      </a: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CA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21 g</a:t>
                      </a: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.40 g</a:t>
                      </a:r>
                      <a:endParaRPr lang="en-C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CA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46 g</a:t>
                      </a: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044092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CA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CA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endParaRPr lang="en-C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.29 g</a:t>
                      </a: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CA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04 g</a:t>
                      </a: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4146532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CA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E</a:t>
                      </a:r>
                      <a:endParaRPr lang="en-CA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CA" sz="1000" b="0" dirty="0"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2.69 g</a:t>
                      </a: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CA" sz="1000" b="0" dirty="0"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4.30 g</a:t>
                      </a: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.00 g</a:t>
                      </a:r>
                      <a:endParaRPr lang="en-C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85 g</a:t>
                      </a: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183255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CA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CA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.38 g</a:t>
                      </a: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CA" sz="1000" dirty="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26 g</a:t>
                      </a:r>
                      <a:endParaRPr lang="en-C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1591418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86EFC1D3-A5E4-F763-37F2-C971DF0797BE}"/>
              </a:ext>
            </a:extLst>
          </p:cNvPr>
          <p:cNvSpPr txBox="1"/>
          <p:nvPr/>
        </p:nvSpPr>
        <p:spPr>
          <a:xfrm>
            <a:off x="866503" y="2969624"/>
            <a:ext cx="57680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Table S1.</a:t>
            </a:r>
          </a:p>
          <a:p>
            <a:endParaRPr lang="en-US" sz="1200" dirty="0"/>
          </a:p>
          <a:p>
            <a:r>
              <a:rPr lang="en-US" sz="1200" dirty="0"/>
              <a:t>Mouse weight the day of data acquisition. </a:t>
            </a:r>
          </a:p>
        </p:txBody>
      </p:sp>
    </p:spTree>
    <p:extLst>
      <p:ext uri="{BB962C8B-B14F-4D97-AF65-F5344CB8AC3E}">
        <p14:creationId xmlns:p14="http://schemas.microsoft.com/office/powerpoint/2010/main" val="8387281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86EFC1D3-A5E4-F763-37F2-C971DF0797BE}"/>
              </a:ext>
            </a:extLst>
          </p:cNvPr>
          <p:cNvSpPr txBox="1"/>
          <p:nvPr/>
        </p:nvSpPr>
        <p:spPr>
          <a:xfrm>
            <a:off x="727162" y="6595474"/>
            <a:ext cx="57680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Table S2.</a:t>
            </a:r>
          </a:p>
          <a:p>
            <a:endParaRPr lang="en-US" sz="1200" dirty="0"/>
          </a:p>
          <a:p>
            <a:r>
              <a:rPr lang="en-US" sz="1200" dirty="0"/>
              <a:t>Cortical area activated per group and cohort/litter (yellow, green and orange : ST mice; shades of blue : EE mice).  </a:t>
            </a:r>
          </a:p>
        </p:txBody>
      </p:sp>
      <p:graphicFrame>
        <p:nvGraphicFramePr>
          <p:cNvPr id="6" name="Content Placeholder 5">
            <a:extLst>
              <a:ext uri="{FF2B5EF4-FFF2-40B4-BE49-F238E27FC236}">
                <a16:creationId xmlns:a16="http://schemas.microsoft.com/office/drawing/2014/main" id="{261A3835-61F4-F7BA-517C-A9F3675BFD91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789204232"/>
              </p:ext>
            </p:extLst>
          </p:nvPr>
        </p:nvGraphicFramePr>
        <p:xfrm>
          <a:off x="797198" y="699499"/>
          <a:ext cx="5307512" cy="5524500"/>
        </p:xfrm>
        <a:graphic>
          <a:graphicData uri="http://schemas.openxmlformats.org/drawingml/2006/table">
            <a:tbl>
              <a:tblPr/>
              <a:tblGrid>
                <a:gridCol w="739678">
                  <a:extLst>
                    <a:ext uri="{9D8B030D-6E8A-4147-A177-3AD203B41FA5}">
                      <a16:colId xmlns:a16="http://schemas.microsoft.com/office/drawing/2014/main" val="3262481039"/>
                    </a:ext>
                  </a:extLst>
                </a:gridCol>
                <a:gridCol w="1245773">
                  <a:extLst>
                    <a:ext uri="{9D8B030D-6E8A-4147-A177-3AD203B41FA5}">
                      <a16:colId xmlns:a16="http://schemas.microsoft.com/office/drawing/2014/main" val="4127200759"/>
                    </a:ext>
                  </a:extLst>
                </a:gridCol>
                <a:gridCol w="259536">
                  <a:extLst>
                    <a:ext uri="{9D8B030D-6E8A-4147-A177-3AD203B41FA5}">
                      <a16:colId xmlns:a16="http://schemas.microsoft.com/office/drawing/2014/main" val="469927029"/>
                    </a:ext>
                  </a:extLst>
                </a:gridCol>
                <a:gridCol w="882422">
                  <a:extLst>
                    <a:ext uri="{9D8B030D-6E8A-4147-A177-3AD203B41FA5}">
                      <a16:colId xmlns:a16="http://schemas.microsoft.com/office/drawing/2014/main" val="747713848"/>
                    </a:ext>
                  </a:extLst>
                </a:gridCol>
                <a:gridCol w="616398">
                  <a:extLst>
                    <a:ext uri="{9D8B030D-6E8A-4147-A177-3AD203B41FA5}">
                      <a16:colId xmlns:a16="http://schemas.microsoft.com/office/drawing/2014/main" val="502803747"/>
                    </a:ext>
                  </a:extLst>
                </a:gridCol>
                <a:gridCol w="949717">
                  <a:extLst>
                    <a:ext uri="{9D8B030D-6E8A-4147-A177-3AD203B41FA5}">
                      <a16:colId xmlns:a16="http://schemas.microsoft.com/office/drawing/2014/main" val="3516026046"/>
                    </a:ext>
                  </a:extLst>
                </a:gridCol>
                <a:gridCol w="613988">
                  <a:extLst>
                    <a:ext uri="{9D8B030D-6E8A-4147-A177-3AD203B41FA5}">
                      <a16:colId xmlns:a16="http://schemas.microsoft.com/office/drawing/2014/main" val="1114720372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Grou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Cortical area activat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627653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32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41770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4.01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Me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St Devi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89038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24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Group of litter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62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0.46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58675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89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Group of litter 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E8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4.03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E8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0.38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E8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E8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36236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E8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4.32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E8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Group of litter 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90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0.39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583791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E8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4.13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E8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223130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E8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47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E8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S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Mean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St Devi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527044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E8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4.21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E8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Litter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27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0.67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671233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4.01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Litter 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61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0.47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130397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4.25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Litter 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27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0.58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123647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91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04003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4.03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601932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4.26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78444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4.09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579527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17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93567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46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B9C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51919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S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18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4033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S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99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94006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S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.65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489324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S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06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9322279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S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88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747336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S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39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11453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S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4.09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10952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S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29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18325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S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3.42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75224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S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.59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659366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S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4.13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608485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S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.91 mm</a:t>
                      </a:r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 Light" panose="020F0302020204030204" pitchFamily="34" charset="0"/>
                          <a:cs typeface="Calibri Light" panose="020F0302020204030204" pitchFamily="34" charset="0"/>
                        </a:rPr>
                        <a:t>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 Light" panose="020F0302020204030204" pitchFamily="34" charset="0"/>
                        <a:ea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08297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424389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C174AB77-C89E-4D76-56AF-310492C16F1A}"/>
              </a:ext>
            </a:extLst>
          </p:cNvPr>
          <p:cNvGrpSpPr/>
          <p:nvPr/>
        </p:nvGrpSpPr>
        <p:grpSpPr>
          <a:xfrm>
            <a:off x="1880400" y="1207595"/>
            <a:ext cx="3475232" cy="2539289"/>
            <a:chOff x="0" y="0"/>
            <a:chExt cx="3321801" cy="2903208"/>
          </a:xfrm>
        </p:grpSpPr>
        <p:graphicFrame>
          <p:nvGraphicFramePr>
            <p:cNvPr id="8" name="Chart 7">
              <a:extLst>
                <a:ext uri="{FF2B5EF4-FFF2-40B4-BE49-F238E27FC236}">
                  <a16:creationId xmlns:a16="http://schemas.microsoft.com/office/drawing/2014/main" id="{E4089C47-949B-D6BA-E0C8-D2BB541DEBD4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635756385"/>
                </p:ext>
              </p:extLst>
            </p:nvPr>
          </p:nvGraphicFramePr>
          <p:xfrm>
            <a:off x="0" y="0"/>
            <a:ext cx="3321801" cy="288991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9" name="TextBox 13">
              <a:extLst>
                <a:ext uri="{FF2B5EF4-FFF2-40B4-BE49-F238E27FC236}">
                  <a16:creationId xmlns:a16="http://schemas.microsoft.com/office/drawing/2014/main" id="{FC57CA6B-C3EF-BE74-0A87-4834C4004FF2}"/>
                </a:ext>
              </a:extLst>
            </p:cNvPr>
            <p:cNvSpPr txBox="1"/>
            <p:nvPr/>
          </p:nvSpPr>
          <p:spPr>
            <a:xfrm>
              <a:off x="1168152" y="2656617"/>
              <a:ext cx="783167" cy="24659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CA" sz="1100" dirty="0"/>
                <a:t>ST</a:t>
              </a:r>
            </a:p>
          </p:txBody>
        </p:sp>
      </p:grpSp>
      <p:pic>
        <p:nvPicPr>
          <p:cNvPr id="11" name="Picture 10">
            <a:extLst>
              <a:ext uri="{FF2B5EF4-FFF2-40B4-BE49-F238E27FC236}">
                <a16:creationId xmlns:a16="http://schemas.microsoft.com/office/drawing/2014/main" id="{3ADBE0B4-3AD6-312C-24EC-66F4EECCD7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47088" y="1207595"/>
            <a:ext cx="660686" cy="2476055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A06C370-FBDA-1254-D33F-DFFB7BB0614D}"/>
              </a:ext>
            </a:extLst>
          </p:cNvPr>
          <p:cNvCxnSpPr>
            <a:cxnSpLocks/>
          </p:cNvCxnSpPr>
          <p:nvPr/>
        </p:nvCxnSpPr>
        <p:spPr>
          <a:xfrm>
            <a:off x="3257550" y="1450613"/>
            <a:ext cx="972000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TextBox 12">
            <a:extLst>
              <a:ext uri="{FF2B5EF4-FFF2-40B4-BE49-F238E27FC236}">
                <a16:creationId xmlns:a16="http://schemas.microsoft.com/office/drawing/2014/main" id="{1E79E473-B3E1-2BD2-F86E-BD25B69C8F12}"/>
              </a:ext>
            </a:extLst>
          </p:cNvPr>
          <p:cNvSpPr txBox="1"/>
          <p:nvPr/>
        </p:nvSpPr>
        <p:spPr>
          <a:xfrm>
            <a:off x="3602340" y="1209314"/>
            <a:ext cx="631824" cy="329141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CA" sz="1800" dirty="0"/>
              <a:t>*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336CA20-BFC2-ADEB-DDB2-4AD05C4F4B1D}"/>
              </a:ext>
            </a:extLst>
          </p:cNvPr>
          <p:cNvSpPr txBox="1"/>
          <p:nvPr/>
        </p:nvSpPr>
        <p:spPr>
          <a:xfrm>
            <a:off x="706774" y="4367072"/>
            <a:ext cx="576804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S2.</a:t>
            </a:r>
          </a:p>
          <a:p>
            <a:endParaRPr lang="en-US" sz="1200" dirty="0"/>
          </a:p>
          <a:p>
            <a:r>
              <a:rPr lang="en-US" sz="1200" dirty="0"/>
              <a:t>Cortical area activated per group and cohort/litter show no apparent litter effect. Individual data points represent individual animals. p =  0.0148. Yellow, green and orange triangles: ST mice; shades of blue circles: EE mice. * p &lt; 0.05 Black line represents the average.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191617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21</TotalTime>
  <Words>379</Words>
  <Application>Microsoft Office PowerPoint</Application>
  <PresentationFormat>Letter Paper (8.5x11 in)</PresentationFormat>
  <Paragraphs>14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-apple-system</vt:lpstr>
      <vt:lpstr>Arial</vt:lpstr>
      <vt:lpstr>Calibri</vt:lpstr>
      <vt:lpstr>Calibri Light</vt:lpstr>
      <vt:lpstr>Cambri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C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livia bibollet</dc:creator>
  <cp:lastModifiedBy>Solenn Tissier</cp:lastModifiedBy>
  <cp:revision>167</cp:revision>
  <dcterms:created xsi:type="dcterms:W3CDTF">2020-06-03T19:25:13Z</dcterms:created>
  <dcterms:modified xsi:type="dcterms:W3CDTF">2023-03-21T19:49:03Z</dcterms:modified>
</cp:coreProperties>
</file>